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42" autoAdjust="0"/>
    <p:restoredTop sz="94660"/>
  </p:normalViewPr>
  <p:slideViewPr>
    <p:cSldViewPr snapToGrid="0" showGuides="1">
      <p:cViewPr varScale="1">
        <p:scale>
          <a:sx n="111" d="100"/>
          <a:sy n="111" d="100"/>
        </p:scale>
        <p:origin x="324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egtyarevanp\Desktop\ssMutpaperNIEHS\Files%20for%20paper%20with%20the%20most%20complete%20data_oct%202017\NewNov2017_combined%20midchrom%20frequencies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egtyarevanp\Desktop\ssMutpaperNIEHS\Files%20for%20paper%20with%20the%20most%20complete%20data_oct%202017\NewNov_2017%20combined%20freq%20for%20all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582376942916798"/>
          <c:y val="0.16451335558363847"/>
          <c:w val="0.72547423773068231"/>
          <c:h val="0.5833454088200952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Combined for wt and with CI'!$L$104</c:f>
              <c:strCache>
                <c:ptCount val="1"/>
                <c:pt idx="0">
                  <c:v>no peroxide  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  <a:effectLst>
              <a:outerShdw blurRad="76200" dist="12700" dir="2700000" sy="-23000" kx="-800400" algn="bl" rotWithShape="0">
                <a:prstClr val="black">
                  <a:alpha val="20000"/>
                </a:prstClr>
              </a:outerShdw>
            </a:effectLst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6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'Combined for wt and with CI'!$AB$104:$AB$107</c:f>
                <c:numCache>
                  <c:formatCode>General</c:formatCode>
                  <c:ptCount val="4"/>
                  <c:pt idx="0">
                    <c:v>4.3623696219035217</c:v>
                  </c:pt>
                  <c:pt idx="1">
                    <c:v>43.913713405238823</c:v>
                  </c:pt>
                  <c:pt idx="2">
                    <c:v>31.471188260385556</c:v>
                  </c:pt>
                  <c:pt idx="3">
                    <c:v>7.3858447488584478</c:v>
                  </c:pt>
                </c:numCache>
              </c:numRef>
            </c:plus>
            <c:minus>
              <c:numRef>
                <c:f>'Combined for wt and with CI'!$AA$104:$AA$107</c:f>
                <c:numCache>
                  <c:formatCode>General</c:formatCode>
                  <c:ptCount val="4"/>
                  <c:pt idx="0">
                    <c:v>3.5595591955476857</c:v>
                  </c:pt>
                  <c:pt idx="1">
                    <c:v>16.598747107221683</c:v>
                  </c:pt>
                  <c:pt idx="2">
                    <c:v>15.983866992789437</c:v>
                  </c:pt>
                  <c:pt idx="3">
                    <c:v>10.22727272727272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ombined for wt and with CI'!$K$105:$K$108</c:f>
              <c:strCache>
                <c:ptCount val="4"/>
                <c:pt idx="0">
                  <c:v>WT</c:v>
                </c:pt>
                <c:pt idx="1">
                  <c:v>ogg1</c:v>
                </c:pt>
                <c:pt idx="2">
                  <c:v>rtt109</c:v>
                </c:pt>
                <c:pt idx="3">
                  <c:v>gcn5</c:v>
                </c:pt>
              </c:strCache>
            </c:strRef>
          </c:cat>
          <c:val>
            <c:numRef>
              <c:f>'Combined for wt and with CI'!$L$105:$L$108</c:f>
              <c:numCache>
                <c:formatCode>0</c:formatCode>
                <c:ptCount val="4"/>
                <c:pt idx="0">
                  <c:v>11.022245762711865</c:v>
                </c:pt>
                <c:pt idx="1">
                  <c:v>57.384987893462466</c:v>
                </c:pt>
                <c:pt idx="2">
                  <c:v>22.792377631087312</c:v>
                </c:pt>
                <c:pt idx="3">
                  <c:v>50.8333333333333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3F7-470F-B818-2E08C411EDB4}"/>
            </c:ext>
          </c:extLst>
        </c:ser>
        <c:ser>
          <c:idx val="1"/>
          <c:order val="1"/>
          <c:tx>
            <c:strRef>
              <c:f>'Combined for wt and with CI'!$M$104</c:f>
              <c:strCache>
                <c:ptCount val="1"/>
                <c:pt idx="0">
                  <c:v>10 mM peroxide</c:v>
                </c:pt>
              </c:strCache>
            </c:strRef>
          </c:tx>
          <c:spPr>
            <a:solidFill>
              <a:schemeClr val="bg2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3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B3F7-470F-B818-2E08C411EDB4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6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'Combined for wt and with CI'!$AE$104:$AE$107</c:f>
                <c:numCache>
                  <c:formatCode>General</c:formatCode>
                  <c:ptCount val="4"/>
                  <c:pt idx="0">
                    <c:v>64.364636166470291</c:v>
                  </c:pt>
                  <c:pt idx="1">
                    <c:v>56.095467032967044</c:v>
                  </c:pt>
                  <c:pt idx="2">
                    <c:v>43.714009971678713</c:v>
                  </c:pt>
                  <c:pt idx="3">
                    <c:v>131.55412424034111</c:v>
                  </c:pt>
                </c:numCache>
              </c:numRef>
            </c:plus>
            <c:minus>
              <c:numRef>
                <c:f>'Combined for wt and with CI'!$AD$104:$AD$107</c:f>
                <c:numCache>
                  <c:formatCode>General</c:formatCode>
                  <c:ptCount val="4"/>
                  <c:pt idx="0">
                    <c:v>17.400069715882651</c:v>
                  </c:pt>
                  <c:pt idx="1">
                    <c:v>29.617750670382232</c:v>
                  </c:pt>
                  <c:pt idx="2">
                    <c:v>31.938061313580377</c:v>
                  </c:pt>
                  <c:pt idx="3">
                    <c:v>134.5120483189695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ombined for wt and with CI'!$K$105:$K$108</c:f>
              <c:strCache>
                <c:ptCount val="4"/>
                <c:pt idx="0">
                  <c:v>WT</c:v>
                </c:pt>
                <c:pt idx="1">
                  <c:v>ogg1</c:v>
                </c:pt>
                <c:pt idx="2">
                  <c:v>rtt109</c:v>
                </c:pt>
                <c:pt idx="3">
                  <c:v>gcn5</c:v>
                </c:pt>
              </c:strCache>
            </c:strRef>
          </c:cat>
          <c:val>
            <c:numRef>
              <c:f>'Combined for wt and with CI'!$M$105:$M$108</c:f>
              <c:numCache>
                <c:formatCode>0</c:formatCode>
                <c:ptCount val="4"/>
                <c:pt idx="0">
                  <c:v>85.635363833529723</c:v>
                </c:pt>
                <c:pt idx="1">
                  <c:v>132.96703296703296</c:v>
                </c:pt>
                <c:pt idx="2">
                  <c:v>145.47517921751052</c:v>
                </c:pt>
                <c:pt idx="3">
                  <c:v>911.390661035732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3F7-470F-B818-2E08C411EDB4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99"/>
        <c:axId val="378680696"/>
        <c:axId val="378681680"/>
      </c:barChart>
      <c:catAx>
        <c:axId val="3786806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1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78681680"/>
        <c:crosses val="autoZero"/>
        <c:auto val="1"/>
        <c:lblAlgn val="ctr"/>
        <c:lblOffset val="100"/>
        <c:noMultiLvlLbl val="0"/>
      </c:catAx>
      <c:valAx>
        <c:axId val="3786816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aseline="0" dirty="0">
                    <a:solidFill>
                      <a:schemeClr val="tx1"/>
                    </a:solidFill>
                  </a:rPr>
                  <a:t>Median frequency Can </a:t>
                </a:r>
                <a:r>
                  <a:rPr lang="en-US" sz="1600" baseline="30000" dirty="0">
                    <a:solidFill>
                      <a:schemeClr val="tx1"/>
                    </a:solidFill>
                  </a:rPr>
                  <a:t>R</a:t>
                </a:r>
                <a:r>
                  <a:rPr lang="en-US" sz="1600" baseline="0" dirty="0">
                    <a:solidFill>
                      <a:schemeClr val="tx1"/>
                    </a:solidFill>
                  </a:rPr>
                  <a:t>, x </a:t>
                </a:r>
                <a:r>
                  <a:rPr lang="en-US" sz="1600" baseline="0">
                    <a:solidFill>
                      <a:schemeClr val="tx1"/>
                    </a:solidFill>
                  </a:rPr>
                  <a:t>10 </a:t>
                </a:r>
                <a:r>
                  <a:rPr lang="en-US" sz="1600" baseline="30000">
                    <a:solidFill>
                      <a:schemeClr val="tx1"/>
                    </a:solidFill>
                  </a:rPr>
                  <a:t>7</a:t>
                </a:r>
                <a:endParaRPr lang="en-US" sz="1600" baseline="30000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8.2210863697380065E-2"/>
              <c:y val="0.1914749783269774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786806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13087751379431123"/>
          <c:y val="0.85472231370318252"/>
          <c:w val="0.82314787774578435"/>
          <c:h val="4.629662032986617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7"/>
    </mc:Choice>
    <mc:Fallback>
      <c:style val="7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960475001487346"/>
          <c:y val="0.12206548706199312"/>
          <c:w val="0.82908573928258966"/>
          <c:h val="0.7064719174242558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J$117</c:f>
              <c:strCache>
                <c:ptCount val="1"/>
                <c:pt idx="0">
                  <c:v> no peroxide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noFill/>
            </a:ln>
            <a:effectLst>
              <a:innerShdw blurRad="63500" dist="50800" dir="18900000">
                <a:prstClr val="black">
                  <a:alpha val="50000"/>
                </a:prstClr>
              </a:innerShdw>
            </a:effectLst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Sheet1!$O$133:$O$135</c:f>
                <c:numCache>
                  <c:formatCode>General</c:formatCode>
                  <c:ptCount val="3"/>
                  <c:pt idx="0">
                    <c:v>13.294704651537089</c:v>
                  </c:pt>
                  <c:pt idx="1">
                    <c:v>6.5981474432178686</c:v>
                  </c:pt>
                  <c:pt idx="2">
                    <c:v>10.872488281789963</c:v>
                  </c:pt>
                </c:numCache>
              </c:numRef>
            </c:plus>
            <c:minus>
              <c:numRef>
                <c:f>Sheet1!$N$133:$N$135</c:f>
                <c:numCache>
                  <c:formatCode>General</c:formatCode>
                  <c:ptCount val="3"/>
                  <c:pt idx="0">
                    <c:v>21.844237594589167</c:v>
                  </c:pt>
                  <c:pt idx="1">
                    <c:v>8.4391120384860603</c:v>
                  </c:pt>
                  <c:pt idx="2">
                    <c:v>23.380332874029023</c:v>
                  </c:pt>
                </c:numCache>
              </c:numRef>
            </c:minus>
            <c:spPr>
              <a:noFill/>
              <a:ln w="12700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Sheet1!$I$118:$I$120</c:f>
              <c:strCache>
                <c:ptCount val="3"/>
                <c:pt idx="0">
                  <c:v>WT</c:v>
                </c:pt>
                <c:pt idx="1">
                  <c:v>gcn5</c:v>
                </c:pt>
                <c:pt idx="2">
                  <c:v>rtt109</c:v>
                </c:pt>
              </c:strCache>
            </c:strRef>
          </c:cat>
          <c:val>
            <c:numRef>
              <c:f>Sheet1!$J$118:$J$120</c:f>
              <c:numCache>
                <c:formatCode>0</c:formatCode>
                <c:ptCount val="3"/>
                <c:pt idx="0">
                  <c:v>56.88073394495413</c:v>
                </c:pt>
                <c:pt idx="1">
                  <c:v>15.023474178403756</c:v>
                </c:pt>
                <c:pt idx="2">
                  <c:v>37.5146084924035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5B7-4EC5-B744-DE9EFAB6BD90}"/>
            </c:ext>
          </c:extLst>
        </c:ser>
        <c:ser>
          <c:idx val="1"/>
          <c:order val="1"/>
          <c:tx>
            <c:strRef>
              <c:f>Sheet1!$K$117</c:f>
              <c:strCache>
                <c:ptCount val="1"/>
                <c:pt idx="0">
                  <c:v>5 mM peroxide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noFill/>
            </a:ln>
            <a:effectLst>
              <a:innerShdw blurRad="63500" dist="50800" dir="18900000">
                <a:prstClr val="black">
                  <a:alpha val="50000"/>
                </a:prstClr>
              </a:innerShdw>
            </a:effectLst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6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Sheet1!$R$133:$R$135</c:f>
                <c:numCache>
                  <c:formatCode>General</c:formatCode>
                  <c:ptCount val="3"/>
                  <c:pt idx="0">
                    <c:v>39.886141256004322</c:v>
                  </c:pt>
                  <c:pt idx="1">
                    <c:v>48.767639385528383</c:v>
                  </c:pt>
                  <c:pt idx="2">
                    <c:v>36.507258931547426</c:v>
                  </c:pt>
                </c:numCache>
              </c:numRef>
            </c:plus>
            <c:minus>
              <c:numRef>
                <c:f>Sheet1!$Q$133:$Q$135</c:f>
                <c:numCache>
                  <c:formatCode>General</c:formatCode>
                  <c:ptCount val="3"/>
                  <c:pt idx="0">
                    <c:v>31.203906137360633</c:v>
                  </c:pt>
                  <c:pt idx="1">
                    <c:v>44.459717137787493</c:v>
                  </c:pt>
                  <c:pt idx="2">
                    <c:v>82.721786339631436</c:v>
                  </c:pt>
                </c:numCache>
              </c:numRef>
            </c:minus>
            <c:spPr>
              <a:noFill/>
              <a:ln w="12700">
                <a:solidFill>
                  <a:schemeClr val="tx1">
                    <a:lumMod val="75000"/>
                    <a:lumOff val="25000"/>
                  </a:schemeClr>
                </a:solidFill>
                <a:round/>
              </a:ln>
              <a:effectLst/>
            </c:spPr>
          </c:errBars>
          <c:cat>
            <c:strRef>
              <c:f>Sheet1!$I$118:$I$120</c:f>
              <c:strCache>
                <c:ptCount val="3"/>
                <c:pt idx="0">
                  <c:v>WT</c:v>
                </c:pt>
                <c:pt idx="1">
                  <c:v>gcn5</c:v>
                </c:pt>
                <c:pt idx="2">
                  <c:v>rtt109</c:v>
                </c:pt>
              </c:strCache>
            </c:strRef>
          </c:cat>
          <c:val>
            <c:numRef>
              <c:f>Sheet1!$K$118:$K$120</c:f>
              <c:numCache>
                <c:formatCode>0</c:formatCode>
                <c:ptCount val="3"/>
                <c:pt idx="0">
                  <c:v>160.11385874399571</c:v>
                </c:pt>
                <c:pt idx="1">
                  <c:v>211.33088278195928</c:v>
                </c:pt>
                <c:pt idx="2">
                  <c:v>169.678308078761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5B7-4EC5-B744-DE9EFAB6BD90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99"/>
        <c:axId val="395029024"/>
        <c:axId val="375483920"/>
      </c:barChart>
      <c:catAx>
        <c:axId val="3950290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1" u="none" strike="noStrike" kern="1200" cap="none" spc="0" normalizeH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75483920"/>
        <c:crosses val="autoZero"/>
        <c:auto val="1"/>
        <c:lblAlgn val="ctr"/>
        <c:lblOffset val="100"/>
        <c:noMultiLvlLbl val="0"/>
      </c:catAx>
      <c:valAx>
        <c:axId val="37548392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cap="all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0" i="0" cap="none" baseline="0" dirty="0">
                    <a:solidFill>
                      <a:schemeClr val="tx1"/>
                    </a:solidFill>
                    <a:effectLst/>
                  </a:rPr>
                  <a:t>Median frequency </a:t>
                </a:r>
                <a:r>
                  <a:rPr lang="en-US" sz="1600" b="0" i="0" cap="none" baseline="0" dirty="0" err="1">
                    <a:solidFill>
                      <a:schemeClr val="tx1"/>
                    </a:solidFill>
                    <a:effectLst/>
                  </a:rPr>
                  <a:t>Can</a:t>
                </a:r>
                <a:r>
                  <a:rPr lang="en-US" sz="1600" b="0" i="0" cap="none" baseline="30000" dirty="0" err="1">
                    <a:solidFill>
                      <a:schemeClr val="tx1"/>
                    </a:solidFill>
                    <a:effectLst/>
                  </a:rPr>
                  <a:t>R</a:t>
                </a:r>
                <a:r>
                  <a:rPr lang="en-US" sz="1600" b="0" i="0" cap="none" baseline="0" dirty="0">
                    <a:solidFill>
                      <a:schemeClr val="tx1"/>
                    </a:solidFill>
                    <a:effectLst/>
                  </a:rPr>
                  <a:t> Red, x 10 </a:t>
                </a:r>
                <a:r>
                  <a:rPr lang="en-US" sz="1600" b="0" i="0" cap="none" baseline="30000" dirty="0">
                    <a:solidFill>
                      <a:schemeClr val="tx1"/>
                    </a:solidFill>
                    <a:effectLst/>
                  </a:rPr>
                  <a:t>7</a:t>
                </a:r>
                <a:endParaRPr lang="en-US" sz="1600" cap="none" dirty="0">
                  <a:solidFill>
                    <a:schemeClr val="tx1"/>
                  </a:solidFill>
                  <a:effectLst/>
                </a:endParaRPr>
              </a:p>
            </c:rich>
          </c:tx>
          <c:layout>
            <c:manualLayout>
              <c:xMode val="edge"/>
              <c:yMode val="edge"/>
              <c:x val="2.4700417438343711E-2"/>
              <c:y val="0.150009783949596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cap="all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50290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ayout>
        <c:manualLayout>
          <c:xMode val="edge"/>
          <c:yMode val="edge"/>
          <c:x val="0.40153799858240063"/>
          <c:y val="0.92129620789238598"/>
          <c:w val="0.40457808398950124"/>
          <c:h val="7.870370370370370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withinLinearReversed" id="25">
  <a:schemeClr val="accent5"/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1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b="0" kern="1200" cap="none" spc="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dk1">
          <a:lumMod val="15000"/>
          <a:lumOff val="85000"/>
        </a:schemeClr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8100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8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tx1">
        <a:lumMod val="65000"/>
        <a:lumOff val="35000"/>
      </a:schemeClr>
    </cs:fontRef>
    <cs:defRPr sz="2000" b="0" kern="1200" cap="none" spc="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round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0761</cdr:x>
      <cdr:y>0</cdr:y>
    </cdr:from>
    <cdr:to>
      <cdr:x>0.71925</cdr:x>
      <cdr:y>0.11166</cdr:y>
    </cdr:to>
    <cdr:sp macro="" textlink="">
      <cdr:nvSpPr>
        <cdr:cNvPr id="2" name="TextBox 3">
          <a:extLst xmlns:a="http://schemas.openxmlformats.org/drawingml/2006/main">
            <a:ext uri="{FF2B5EF4-FFF2-40B4-BE49-F238E27FC236}">
              <a16:creationId xmlns:a16="http://schemas.microsoft.com/office/drawing/2014/main" id="{6E5C21A0-FB1B-450C-8A09-696F747D2708}"/>
            </a:ext>
          </a:extLst>
        </cdr:cNvPr>
        <cdr:cNvSpPr txBox="1"/>
      </cdr:nvSpPr>
      <cdr:spPr>
        <a:xfrm xmlns:a="http://schemas.openxmlformats.org/drawingml/2006/main">
          <a:off x="2533049" y="0"/>
          <a:ext cx="1936685" cy="64633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dirty="0"/>
            <a:t>dsDNA reporter:</a:t>
          </a:r>
        </a:p>
        <a:p xmlns:a="http://schemas.openxmlformats.org/drawingml/2006/main">
          <a:pPr algn="ctr"/>
          <a:r>
            <a:rPr lang="en-US" dirty="0"/>
            <a:t>selection for </a:t>
          </a:r>
          <a:r>
            <a:rPr lang="en-US" dirty="0" err="1"/>
            <a:t>CanR</a:t>
          </a:r>
          <a:r>
            <a:rPr lang="en-US" dirty="0"/>
            <a:t> 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7137</cdr:x>
      <cdr:y>0.53279</cdr:y>
    </cdr:from>
    <cdr:to>
      <cdr:x>0.9058</cdr:x>
      <cdr:y>0.62065</cdr:y>
    </cdr:to>
    <cdr:grpSp>
      <cdr:nvGrpSpPr>
        <cdr:cNvPr id="5" name="Group 4">
          <a:extLst xmlns:a="http://schemas.openxmlformats.org/drawingml/2006/main">
            <a:ext uri="{FF2B5EF4-FFF2-40B4-BE49-F238E27FC236}">
              <a16:creationId xmlns:a16="http://schemas.microsoft.com/office/drawing/2014/main" id="{E440009B-8C3F-4066-A173-2B14F418B059}"/>
            </a:ext>
          </a:extLst>
        </cdr:cNvPr>
        <cdr:cNvGrpSpPr/>
      </cdr:nvGrpSpPr>
      <cdr:grpSpPr>
        <a:xfrm xmlns:a="http://schemas.openxmlformats.org/drawingml/2006/main">
          <a:off x="1768424" y="2818073"/>
          <a:ext cx="4134358" cy="464716"/>
          <a:chOff x="2184844" y="2653988"/>
          <a:chExt cx="5108015" cy="437627"/>
        </a:xfrm>
      </cdr:grpSpPr>
      <cdr:sp macro="" textlink="">
        <cdr:nvSpPr>
          <cdr:cNvPr id="2" name="TextBox 8">
            <a:extLst xmlns:a="http://schemas.openxmlformats.org/drawingml/2006/main">
              <a:ext uri="{FF2B5EF4-FFF2-40B4-BE49-F238E27FC236}">
                <a16:creationId xmlns:a16="http://schemas.microsoft.com/office/drawing/2014/main" id="{D4E42F72-01D5-4EB5-B587-3317D0962832}"/>
              </a:ext>
            </a:extLst>
          </cdr:cNvPr>
          <cdr:cNvSpPr txBox="1"/>
        </cdr:nvSpPr>
        <cdr:spPr>
          <a:xfrm xmlns:a="http://schemas.openxmlformats.org/drawingml/2006/main">
            <a:off x="2184844" y="2722283"/>
            <a:ext cx="651140" cy="369332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pPr algn="ctr"/>
            <a:r>
              <a:rPr lang="en-US" dirty="0"/>
              <a:t>+103</a:t>
            </a:r>
          </a:p>
        </cdr:txBody>
      </cdr:sp>
      <cdr:sp macro="" textlink="">
        <cdr:nvSpPr>
          <cdr:cNvPr id="3" name="TextBox 9">
            <a:extLst xmlns:a="http://schemas.openxmlformats.org/drawingml/2006/main">
              <a:ext uri="{FF2B5EF4-FFF2-40B4-BE49-F238E27FC236}">
                <a16:creationId xmlns:a16="http://schemas.microsoft.com/office/drawing/2014/main" id="{609C0213-55C6-4CA5-A8C8-05B2B409DF75}"/>
              </a:ext>
            </a:extLst>
          </cdr:cNvPr>
          <cdr:cNvSpPr txBox="1"/>
        </cdr:nvSpPr>
        <cdr:spPr>
          <a:xfrm xmlns:a="http://schemas.openxmlformats.org/drawingml/2006/main">
            <a:off x="4404216" y="2704209"/>
            <a:ext cx="651140" cy="369332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pPr algn="ctr"/>
            <a:r>
              <a:rPr lang="en-US" dirty="0"/>
              <a:t>+196</a:t>
            </a:r>
          </a:p>
        </cdr:txBody>
      </cdr:sp>
      <cdr:sp macro="" textlink="">
        <cdr:nvSpPr>
          <cdr:cNvPr id="4" name="TextBox 10">
            <a:extLst xmlns:a="http://schemas.openxmlformats.org/drawingml/2006/main">
              <a:ext uri="{FF2B5EF4-FFF2-40B4-BE49-F238E27FC236}">
                <a16:creationId xmlns:a16="http://schemas.microsoft.com/office/drawing/2014/main" id="{F4911FBB-7D6B-42A7-BFC6-1EFF3FD88021}"/>
              </a:ext>
            </a:extLst>
          </cdr:cNvPr>
          <cdr:cNvSpPr txBox="1"/>
        </cdr:nvSpPr>
        <cdr:spPr>
          <a:xfrm xmlns:a="http://schemas.openxmlformats.org/drawingml/2006/main">
            <a:off x="6641719" y="2653988"/>
            <a:ext cx="651140" cy="369332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pPr algn="ctr"/>
            <a:r>
              <a:rPr lang="en-US" dirty="0"/>
              <a:t>+132</a:t>
            </a:r>
          </a:p>
        </cdr:txBody>
      </cdr:sp>
    </cdr:grpSp>
  </cdr:relSizeAnchor>
  <cdr:relSizeAnchor xmlns:cdr="http://schemas.openxmlformats.org/drawingml/2006/chartDrawing">
    <cdr:from>
      <cdr:x>0.37187</cdr:x>
      <cdr:y>0</cdr:y>
    </cdr:from>
    <cdr:to>
      <cdr:x>0.65691</cdr:x>
      <cdr:y>0.12615</cdr:y>
    </cdr:to>
    <cdr:sp macro="" textlink="">
      <cdr:nvSpPr>
        <cdr:cNvPr id="6" name="TextBox 3">
          <a:extLst xmlns:a="http://schemas.openxmlformats.org/drawingml/2006/main">
            <a:ext uri="{FF2B5EF4-FFF2-40B4-BE49-F238E27FC236}">
              <a16:creationId xmlns:a16="http://schemas.microsoft.com/office/drawing/2014/main" id="{6E5C21A0-FB1B-450C-8A09-696F747D2708}"/>
            </a:ext>
          </a:extLst>
        </cdr:cNvPr>
        <cdr:cNvSpPr txBox="1"/>
      </cdr:nvSpPr>
      <cdr:spPr>
        <a:xfrm xmlns:a="http://schemas.openxmlformats.org/drawingml/2006/main">
          <a:off x="2423356" y="0"/>
          <a:ext cx="1857507" cy="66724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dirty="0"/>
            <a:t>ssDNA reporter:</a:t>
          </a:r>
        </a:p>
        <a:p xmlns:a="http://schemas.openxmlformats.org/drawingml/2006/main">
          <a:pPr algn="ctr"/>
          <a:r>
            <a:rPr lang="en-US" dirty="0"/>
            <a:t>selection for </a:t>
          </a:r>
          <a:r>
            <a:rPr lang="en-US" dirty="0" err="1"/>
            <a:t>CanR</a:t>
          </a:r>
          <a:r>
            <a:rPr lang="en-US" dirty="0"/>
            <a:t> Red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F72627-7452-4940-8128-9A8BB9CFD72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D110266-6018-49CD-9DD5-3E0C4552689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52CAF0-AB4C-4CD3-BF94-FE890E70CC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23A40-D96C-43BD-BDC4-0074CA1B1FC0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710686-5637-42F4-8AA7-8CAE95D1F0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779B09-05D0-41E4-9439-06A86E54E2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775D-1315-4926-9477-B5438AF1EB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7240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E09EB3-72CB-4E24-9502-610F9B774F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3A26E65-758D-45AB-9CB7-7738E09104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4DAE47-CAFC-4D17-8E7D-7B9AC3882F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23A40-D96C-43BD-BDC4-0074CA1B1FC0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73C630-CFD2-4DBF-95B4-1283C76BE5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9427B8-7C45-44FF-9562-F22CB55AA2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775D-1315-4926-9477-B5438AF1EB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24986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2AE71E4-F825-41E1-8B29-4CFE962B356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3DAB815-B35E-43BE-B183-43761B3E078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B87BFB-E362-4253-BDEF-ECDD997964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23A40-D96C-43BD-BDC4-0074CA1B1FC0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0C12EB-5197-487E-A423-A192C4BE7B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3445E7-26FC-41B4-BD38-A3C53C58AD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775D-1315-4926-9477-B5438AF1EB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14315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D86D9D-F123-4D74-B374-B48ACEB780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E73590-C779-4673-BCE3-4557DE57877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181C5C-943A-4F6F-9C74-32DA7AB0E7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23A40-D96C-43BD-BDC4-0074CA1B1FC0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8496A3-2446-4360-BE05-70D5A11DF1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28490B-CFAB-4ED6-B7AB-97B9E207D2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775D-1315-4926-9477-B5438AF1EB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78963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D9B498-5A4F-4F42-ACE8-9CCF20D4A8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231F07-38D7-4C4B-B47E-906952BD27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ACF9B8-F881-401B-B607-36C596F563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23A40-D96C-43BD-BDC4-0074CA1B1FC0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12AD7B-4CAD-4B1C-843C-7B367B7B77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ABD67C-D0B6-47E1-BA23-C39BB846E1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775D-1315-4926-9477-B5438AF1EB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1244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EFA97F-078D-4391-81CA-ECE007FD9C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B925E38-896E-4DD0-8DCE-9F0509854A8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27D53E1-C48D-4978-808E-9D71AD52D6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A36C5AA-CDDF-48BD-B990-CF7A7BFA95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23A40-D96C-43BD-BDC4-0074CA1B1FC0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9178A1-7A64-48CF-A56B-911E592B12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6C73CFE-D0F6-4796-B66A-DDFD2DCC8E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775D-1315-4926-9477-B5438AF1EB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45953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153E6E-BD0C-4BCF-9ED2-E8F2E20071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2B137A-05A6-4993-A4A3-8E70C8F9A0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A80BC65-61CB-409F-B8B2-8E9AB7EF94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AEB5A0A-F280-46FA-88F1-ED0BF57E90B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BD4F557-9441-4421-8CF2-CAB9BE16BC2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9C43410-B4D1-4B63-B654-51609EA32E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23A40-D96C-43BD-BDC4-0074CA1B1FC0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0987743-EC19-42CA-8143-8F1FDCBA61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BF168E5-C44D-45A0-8241-7F90C90AE2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775D-1315-4926-9477-B5438AF1EB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38868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EF5CA5-FCB0-4B6E-98AE-4335002292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C5642EA-0546-4CBE-979E-9280737F49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23A40-D96C-43BD-BDC4-0074CA1B1FC0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460225C-7931-487F-87A4-37F7B9EFE2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EB96843-CDD2-4786-86DA-D710108E8F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775D-1315-4926-9477-B5438AF1EB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8006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4D024CB-F008-4058-81DA-392FBB2DA2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23A40-D96C-43BD-BDC4-0074CA1B1FC0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F45BF7-D06F-4C7C-9D03-92DC69ADCE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7E3110E-ED35-4361-8A5D-125735C27D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775D-1315-4926-9477-B5438AF1EB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85370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E5CD36-60B3-485F-9E89-F678AE27A1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7FE074-99AF-4D00-A14B-43149FE35CD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F7CC762-6226-4BF7-B3A6-B954AB9C99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05A632-4CD4-49D1-A361-DCB4B60BA3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23A40-D96C-43BD-BDC4-0074CA1B1FC0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DA3421-6147-4AF1-A270-985DFB69B5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9BEFD6-E0D8-4659-9657-324327AC1D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775D-1315-4926-9477-B5438AF1EB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078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F31DD4-D2F1-4D0F-9FF8-E30B37BB6F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E0EFE97-DDF8-4439-8CD4-BC0F969D984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5753654-A076-481F-936E-A5292E5CE8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FA9F8C1-4B1A-40B8-923B-010DAEF25C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23A40-D96C-43BD-BDC4-0074CA1B1FC0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69EF181-1C8D-4E5A-AF7F-CE3B2E958E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B21378-7556-4BE0-9EF4-F2258F6D08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775D-1315-4926-9477-B5438AF1EB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40641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734DF6C-151E-48C6-BA68-FABDA9BC0C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C2EEA8-A43D-4334-B7E8-D7F8FC95D8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39649A-FFB6-40F3-B28E-3580E6840F7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A23A40-D96C-43BD-BDC4-0074CA1B1FC0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A74CC8-AE38-41B2-AB05-9D288CF2E28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92D094-09E8-455A-869C-EF28DE9FDCD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09775D-1315-4926-9477-B5438AF1EB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6569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DCD83543-1FDE-4431-90DE-959C3DFD018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95637947"/>
              </p:ext>
            </p:extLst>
          </p:nvPr>
        </p:nvGraphicFramePr>
        <p:xfrm>
          <a:off x="-351504" y="458351"/>
          <a:ext cx="6214422" cy="5864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0EF7CB2F-0A69-4172-A420-EEF2A30751B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91493651"/>
              </p:ext>
            </p:extLst>
          </p:nvPr>
        </p:nvGraphicFramePr>
        <p:xfrm>
          <a:off x="5675349" y="458351"/>
          <a:ext cx="6516651" cy="52892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090AA9D1-2A7A-43CD-8B93-7D24A97F8687}"/>
              </a:ext>
            </a:extLst>
          </p:cNvPr>
          <p:cNvSpPr txBox="1"/>
          <p:nvPr/>
        </p:nvSpPr>
        <p:spPr>
          <a:xfrm>
            <a:off x="307310" y="19344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E93A470-5168-4EAE-9D2C-B3042F94E765}"/>
              </a:ext>
            </a:extLst>
          </p:cNvPr>
          <p:cNvSpPr txBox="1"/>
          <p:nvPr/>
        </p:nvSpPr>
        <p:spPr>
          <a:xfrm>
            <a:off x="6170226" y="193442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9232238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37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gtyareva, Natalya (NIH/NIEHS) [C]</dc:creator>
  <cp:lastModifiedBy>Degtyareva, Natalya (NIH/NIEHS) [C]</cp:lastModifiedBy>
  <cp:revision>5</cp:revision>
  <dcterms:created xsi:type="dcterms:W3CDTF">2018-10-18T20:08:36Z</dcterms:created>
  <dcterms:modified xsi:type="dcterms:W3CDTF">2019-04-09T18:00:02Z</dcterms:modified>
</cp:coreProperties>
</file>